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59" r:id="rId2"/>
    <p:sldId id="260" r:id="rId3"/>
    <p:sldId id="261" r:id="rId4"/>
    <p:sldId id="262" r:id="rId5"/>
    <p:sldId id="263" r:id="rId6"/>
    <p:sldId id="258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71156" autoAdjust="0"/>
  </p:normalViewPr>
  <p:slideViewPr>
    <p:cSldViewPr snapToGrid="0" snapToObjects="1">
      <p:cViewPr varScale="1">
        <p:scale>
          <a:sx n="67" d="100"/>
          <a:sy n="67" d="100"/>
        </p:scale>
        <p:origin x="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AD59E8-C6C0-4F6D-9AD2-A563237495FA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D2D507-FE77-4B15-B813-995214BA8E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736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plementary Figure 1A-C. Relapse-free survival (RFS) in TMDU cohort stratified according to gene mutations; (1A) (A) </a:t>
            </a:r>
            <a:r>
              <a:rPr kumimoji="1" lang="en-US" altLang="ja-JP" i="1" dirty="0"/>
              <a:t>TP53</a:t>
            </a:r>
            <a:r>
              <a:rPr kumimoji="1" lang="en-US" altLang="ja-JP" dirty="0"/>
              <a:t>, (B) </a:t>
            </a:r>
            <a:r>
              <a:rPr kumimoji="1" lang="en-US" altLang="ja-JP" i="1" dirty="0"/>
              <a:t>KRAS</a:t>
            </a:r>
            <a:r>
              <a:rPr kumimoji="1" lang="en-US" altLang="ja-JP" dirty="0"/>
              <a:t>, (C) </a:t>
            </a:r>
            <a:r>
              <a:rPr kumimoji="1" lang="en-US" altLang="ja-JP" i="1" dirty="0"/>
              <a:t>EGFR</a:t>
            </a:r>
            <a:r>
              <a:rPr kumimoji="1" lang="en-US" altLang="ja-JP" dirty="0"/>
              <a:t>, (D) </a:t>
            </a:r>
            <a:r>
              <a:rPr kumimoji="1" lang="en-US" altLang="ja-JP" i="1" dirty="0"/>
              <a:t>PIK3CA; </a:t>
            </a:r>
            <a:r>
              <a:rPr kumimoji="1" lang="en-US" altLang="ja-JP" i="0" dirty="0"/>
              <a:t>(1B) </a:t>
            </a:r>
            <a:r>
              <a:rPr kumimoji="1" lang="en-US" altLang="ja-JP" dirty="0"/>
              <a:t>(E) </a:t>
            </a:r>
            <a:r>
              <a:rPr kumimoji="1" lang="en-US" altLang="ja-JP" i="1" dirty="0"/>
              <a:t>CDKN2A</a:t>
            </a:r>
            <a:r>
              <a:rPr kumimoji="1" lang="en-US" altLang="ja-JP" dirty="0"/>
              <a:t>, (F) </a:t>
            </a:r>
            <a:r>
              <a:rPr kumimoji="1" lang="en-US" altLang="ja-JP" i="1" dirty="0"/>
              <a:t>NF1</a:t>
            </a:r>
            <a:r>
              <a:rPr kumimoji="1" lang="en-US" altLang="ja-JP" dirty="0"/>
              <a:t>, (G) </a:t>
            </a:r>
            <a:r>
              <a:rPr kumimoji="1" lang="en-US" altLang="ja-JP" i="1" dirty="0"/>
              <a:t>NFE2L2</a:t>
            </a:r>
            <a:r>
              <a:rPr kumimoji="1" lang="en-US" altLang="ja-JP" dirty="0"/>
              <a:t>, (H) </a:t>
            </a:r>
            <a:r>
              <a:rPr kumimoji="1" lang="en-US" altLang="ja-JP" i="1" dirty="0"/>
              <a:t>SMAD4;</a:t>
            </a:r>
            <a:r>
              <a:rPr kumimoji="1" lang="en-US" altLang="ja-JP" dirty="0"/>
              <a:t> (1C) (I) </a:t>
            </a:r>
            <a:r>
              <a:rPr kumimoji="1" lang="en-US" altLang="ja-JP" i="1" dirty="0"/>
              <a:t>STK11</a:t>
            </a:r>
            <a:r>
              <a:rPr kumimoji="1" lang="en-US" altLang="ja-JP" dirty="0"/>
              <a:t>. </a:t>
            </a:r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D2D507-FE77-4B15-B813-995214BA8EE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74789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D2D507-FE77-4B15-B813-995214BA8EE0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92394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plementary Figure 2A-B. Relapse-free survival (RFS) in TMDU cohort stratified according to candidate prognostic factors in ref 10; (2A) (A) Age, (B) T factor, (C) Lymphatic invasion, (D) Vascular invasion; (2B) (E) Visceral pleural invasion. </a:t>
            </a:r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D2D507-FE77-4B15-B813-995214BA8EE0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66557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plementary Figure 3. Relapse-free survival (RFS) of visceral pleural invasion negative (A) and positive group (B) in TMDU cohort. RFS is stratified by RAS/TP53 wild type and mutant patients in </a:t>
            </a:r>
            <a:r>
              <a:rPr kumimoji="1" lang="en-US" altLang="ja-JP"/>
              <a:t>each group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D2D507-FE77-4B15-B813-995214BA8EE0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05671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295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887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850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855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351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2729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132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446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010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818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914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7E9072-F653-2348-ACAF-7DA8AC5BB598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986AFF-A3DE-664C-9734-0FD7F70D39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020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D15C857-2045-ECE3-00E7-C0B8992A39A1}"/>
              </a:ext>
            </a:extLst>
          </p:cNvPr>
          <p:cNvSpPr txBox="1"/>
          <p:nvPr/>
        </p:nvSpPr>
        <p:spPr>
          <a:xfrm>
            <a:off x="1" y="26253"/>
            <a:ext cx="39578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A</a:t>
            </a:r>
            <a:endParaRPr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5DED6491-973B-6200-D5A2-DBCFE07BF8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616" y="828000"/>
            <a:ext cx="3903569" cy="2916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FC201AA-B8E6-68F2-A8A4-508F067D8B6F}"/>
              </a:ext>
            </a:extLst>
          </p:cNvPr>
          <p:cNvSpPr txBox="1"/>
          <p:nvPr/>
        </p:nvSpPr>
        <p:spPr>
          <a:xfrm>
            <a:off x="234053" y="828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CA2D157B-D15B-ED88-E037-809068FA76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2000" y="828000"/>
            <a:ext cx="3900487" cy="2913698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A70FA7E-7D30-80CA-B13C-41B961EF3C9B}"/>
              </a:ext>
            </a:extLst>
          </p:cNvPr>
          <p:cNvSpPr txBox="1"/>
          <p:nvPr/>
        </p:nvSpPr>
        <p:spPr>
          <a:xfrm>
            <a:off x="4464000" y="828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22DD5AB0-45C3-6DBE-C247-A1ACEE2D14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000" y="3780000"/>
            <a:ext cx="3900487" cy="2913698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EF93128-0946-D686-8531-180B281F7D7C}"/>
              </a:ext>
            </a:extLst>
          </p:cNvPr>
          <p:cNvSpPr txBox="1"/>
          <p:nvPr/>
        </p:nvSpPr>
        <p:spPr>
          <a:xfrm>
            <a:off x="234000" y="3780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A87A1AF2-AED3-01E7-F6F0-570A82C4EC4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72000" y="3780000"/>
            <a:ext cx="3900487" cy="2913698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9F43A58-5BBA-28A9-E309-21E5373F5E94}"/>
              </a:ext>
            </a:extLst>
          </p:cNvPr>
          <p:cNvSpPr txBox="1"/>
          <p:nvPr/>
        </p:nvSpPr>
        <p:spPr>
          <a:xfrm>
            <a:off x="4464000" y="3780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86623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5BF9866-6098-69B6-FF64-1E2DEADF00CC}"/>
              </a:ext>
            </a:extLst>
          </p:cNvPr>
          <p:cNvSpPr txBox="1"/>
          <p:nvPr/>
        </p:nvSpPr>
        <p:spPr>
          <a:xfrm>
            <a:off x="1" y="26253"/>
            <a:ext cx="39578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B</a:t>
            </a:r>
            <a:endParaRPr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0E602460-EE19-B395-1A36-25884D87F3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00" y="828000"/>
            <a:ext cx="3900487" cy="2913698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E54E0B2C-B46C-B744-0156-F57C81A1F0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2000" y="828000"/>
            <a:ext cx="3900487" cy="2913698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479B973-B510-6D7B-96EF-A696A3729244}"/>
              </a:ext>
            </a:extLst>
          </p:cNvPr>
          <p:cNvSpPr txBox="1"/>
          <p:nvPr/>
        </p:nvSpPr>
        <p:spPr>
          <a:xfrm>
            <a:off x="197135" y="801544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AEE0517-6EC9-74D3-3F53-43182FB9DE34}"/>
              </a:ext>
            </a:extLst>
          </p:cNvPr>
          <p:cNvSpPr txBox="1"/>
          <p:nvPr/>
        </p:nvSpPr>
        <p:spPr>
          <a:xfrm>
            <a:off x="4465161" y="8280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9200BE12-0F97-7A4E-0DB0-13BDADFF8EA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000" y="3780000"/>
            <a:ext cx="3900487" cy="2913698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7E945EB0-9286-778F-F0C8-A7FBDAB0C13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72000" y="3780000"/>
            <a:ext cx="3900487" cy="2913698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4DF1F1E-073B-C3AA-4AB2-44DE31B3D159}"/>
              </a:ext>
            </a:extLst>
          </p:cNvPr>
          <p:cNvSpPr txBox="1"/>
          <p:nvPr/>
        </p:nvSpPr>
        <p:spPr>
          <a:xfrm>
            <a:off x="234000" y="3780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91D9D25-7559-9216-308A-B50CC76EFAFB}"/>
              </a:ext>
            </a:extLst>
          </p:cNvPr>
          <p:cNvSpPr txBox="1"/>
          <p:nvPr/>
        </p:nvSpPr>
        <p:spPr>
          <a:xfrm>
            <a:off x="4464000" y="3780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94744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14EB907-C985-B666-6881-78DD1B7B02A7}"/>
              </a:ext>
            </a:extLst>
          </p:cNvPr>
          <p:cNvSpPr txBox="1"/>
          <p:nvPr/>
        </p:nvSpPr>
        <p:spPr>
          <a:xfrm>
            <a:off x="1" y="26253"/>
            <a:ext cx="39578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C</a:t>
            </a:r>
            <a:endParaRPr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13B47F8B-9AE9-1706-3734-E7C9FBA00B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0" y="828000"/>
            <a:ext cx="3900487" cy="291369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BFDE0CF-4407-4E0B-309F-DA1E589C34D0}"/>
              </a:ext>
            </a:extLst>
          </p:cNvPr>
          <p:cNvSpPr txBox="1"/>
          <p:nvPr/>
        </p:nvSpPr>
        <p:spPr>
          <a:xfrm>
            <a:off x="198000" y="80280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05074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FA21A75-EEA0-A447-12A4-94CF2F2CC1A9}"/>
              </a:ext>
            </a:extLst>
          </p:cNvPr>
          <p:cNvSpPr txBox="1"/>
          <p:nvPr/>
        </p:nvSpPr>
        <p:spPr>
          <a:xfrm>
            <a:off x="-1" y="0"/>
            <a:ext cx="39004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A</a:t>
            </a:r>
            <a:endParaRPr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467D61CE-FA84-FB99-FE36-F87E77506C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00" y="828000"/>
            <a:ext cx="3900487" cy="2913698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7FF42D22-CEA8-4303-6FCA-3AD112F6B5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07832" y="818400"/>
            <a:ext cx="3900487" cy="291369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4929A114-47F5-CE74-C97E-773D93116F4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000" y="3780000"/>
            <a:ext cx="3900487" cy="2913698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559C894D-34FF-C9AE-AF53-B05E861FD2E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72000" y="3780000"/>
            <a:ext cx="3900487" cy="2913698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E9DED7A-7789-63DC-5BAC-45DDFE56AFD2}"/>
              </a:ext>
            </a:extLst>
          </p:cNvPr>
          <p:cNvSpPr txBox="1"/>
          <p:nvPr/>
        </p:nvSpPr>
        <p:spPr>
          <a:xfrm>
            <a:off x="198000" y="828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D052A00-6E7C-05F3-DD02-C8D202F85C58}"/>
              </a:ext>
            </a:extLst>
          </p:cNvPr>
          <p:cNvSpPr txBox="1"/>
          <p:nvPr/>
        </p:nvSpPr>
        <p:spPr>
          <a:xfrm>
            <a:off x="4464000" y="828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0B47BB8-1418-4D9C-9112-D175EACF1835}"/>
              </a:ext>
            </a:extLst>
          </p:cNvPr>
          <p:cNvSpPr txBox="1"/>
          <p:nvPr/>
        </p:nvSpPr>
        <p:spPr>
          <a:xfrm>
            <a:off x="234000" y="3780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6A37BB7-9254-9F68-0588-85BE96629EF9}"/>
              </a:ext>
            </a:extLst>
          </p:cNvPr>
          <p:cNvSpPr txBox="1"/>
          <p:nvPr/>
        </p:nvSpPr>
        <p:spPr>
          <a:xfrm>
            <a:off x="4464000" y="3780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08586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1039A7C-1893-F68B-D1D2-D1043AE74432}"/>
              </a:ext>
            </a:extLst>
          </p:cNvPr>
          <p:cNvSpPr txBox="1"/>
          <p:nvPr/>
        </p:nvSpPr>
        <p:spPr>
          <a:xfrm>
            <a:off x="-1" y="0"/>
            <a:ext cx="39004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B</a:t>
            </a:r>
            <a:endParaRPr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B9ED6863-CADD-2B55-D63C-FAC37A9ED8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0" y="828000"/>
            <a:ext cx="3900487" cy="291369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C1CDC5F-5915-5F44-5BEF-DD1843190F35}"/>
              </a:ext>
            </a:extLst>
          </p:cNvPr>
          <p:cNvSpPr txBox="1"/>
          <p:nvPr/>
        </p:nvSpPr>
        <p:spPr>
          <a:xfrm>
            <a:off x="198000" y="8280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98910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2B8D04B-79B0-6D6F-3683-85DE33D48181}"/>
              </a:ext>
            </a:extLst>
          </p:cNvPr>
          <p:cNvSpPr txBox="1"/>
          <p:nvPr/>
        </p:nvSpPr>
        <p:spPr>
          <a:xfrm>
            <a:off x="0" y="11089"/>
            <a:ext cx="36303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9424EF9-E25F-DBE2-2973-7339A26C71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601" y="1435290"/>
            <a:ext cx="4313873" cy="330708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87D82184-8783-249A-2CF3-86EEDD5B01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2000" y="1435290"/>
            <a:ext cx="4313873" cy="3307080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E60751F-9D98-C1ED-F733-CC1F5468590A}"/>
              </a:ext>
            </a:extLst>
          </p:cNvPr>
          <p:cNvSpPr txBox="1"/>
          <p:nvPr/>
        </p:nvSpPr>
        <p:spPr>
          <a:xfrm>
            <a:off x="755576" y="106595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2C3DFAA-8CEB-6AD5-4EBA-DA1F4F377709}"/>
              </a:ext>
            </a:extLst>
          </p:cNvPr>
          <p:cNvSpPr txBox="1"/>
          <p:nvPr/>
        </p:nvSpPr>
        <p:spPr>
          <a:xfrm>
            <a:off x="4913919" y="103369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7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</TotalTime>
  <Words>211</Words>
  <Application>Microsoft Office PowerPoint</Application>
  <PresentationFormat>画面に合わせる (4:3)</PresentationFormat>
  <Paragraphs>29</Paragraphs>
  <Slides>6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ndo Satoshi</dc:creator>
  <cp:lastModifiedBy>本多 隆行</cp:lastModifiedBy>
  <cp:revision>9</cp:revision>
  <dcterms:created xsi:type="dcterms:W3CDTF">2022-06-15T19:54:19Z</dcterms:created>
  <dcterms:modified xsi:type="dcterms:W3CDTF">2023-05-19T04:03:05Z</dcterms:modified>
</cp:coreProperties>
</file>